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03CB45-8A23-46BF-B1E8-BC7F2D595A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4E297-0BBA-48C5-AE18-95ED288A03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1B013-7C09-4F44-B633-72AF226D37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6EE16-D1B8-42EE-949B-A9836A04D6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4D72B-7FED-4331-9E80-F059874A04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EE50E-D6AF-41D9-AD0E-A2025DA4FB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E9AF5-A0C7-4D72-A8E4-61E3E80540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8588D-3FD2-4951-9CC2-85AB0AAD5A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A5AD6-915C-4910-8E0C-31D79C3DB9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3CC11-D620-44E5-A5BF-140370F18F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983B4-225D-4A09-8759-C50645040D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F8125-4527-40D1-989E-629FA2843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C46470F-1F89-452B-8038-FF9AB552F9B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1878120" y="5029200"/>
            <a:ext cx="3114720" cy="280980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1865160" y="2066760"/>
            <a:ext cx="3048120" cy="2810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7"/>
          <p:cNvSpPr/>
          <p:nvPr/>
        </p:nvSpPr>
        <p:spPr>
          <a:xfrm>
            <a:off x="2908440" y="1406520"/>
            <a:ext cx="87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"/>
          <p:cNvSpPr/>
          <p:nvPr/>
        </p:nvSpPr>
        <p:spPr>
          <a:xfrm rot="16200000">
            <a:off x="533880" y="3170520"/>
            <a:ext cx="1870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expression 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FOXM1/L19 mRN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6"/>
          <p:cNvSpPr/>
          <p:nvPr/>
        </p:nvSpPr>
        <p:spPr>
          <a:xfrm rot="16200000">
            <a:off x="584640" y="6097680"/>
            <a:ext cx="1870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lative expression 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OTUB1/L19 mRN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ight Brace 2"/>
          <p:cNvSpPr/>
          <p:nvPr/>
        </p:nvSpPr>
        <p:spPr>
          <a:xfrm flipV="1" rot="16200000">
            <a:off x="3892680" y="5329800"/>
            <a:ext cx="144720" cy="971640"/>
          </a:xfrm>
          <a:custGeom>
            <a:avLst/>
            <a:gdLst>
              <a:gd name="textAreaLeft" fmla="*/ 0 w 144720"/>
              <a:gd name="textAreaRight" fmla="*/ 52200 w 144720"/>
              <a:gd name="textAreaTop" fmla="*/ 3600 h 971640"/>
              <a:gd name="textAreaBottom" fmla="*/ 968040 h 97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34"/>
                  <a:pt x="10800" y="267"/>
                </a:cubicBezTo>
                <a:lnTo>
                  <a:pt x="10800" y="10533"/>
                </a:lnTo>
                <a:cubicBezTo>
                  <a:pt x="10800" y="10667"/>
                  <a:pt x="16200" y="10800"/>
                  <a:pt x="21600" y="10800"/>
                </a:cubicBezTo>
                <a:cubicBezTo>
                  <a:pt x="16200" y="10800"/>
                  <a:pt x="10800" y="10934"/>
                  <a:pt x="10800" y="11067"/>
                </a:cubicBezTo>
                <a:lnTo>
                  <a:pt x="10800" y="21333"/>
                </a:lnTo>
                <a:cubicBezTo>
                  <a:pt x="10800" y="2146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3782160" y="55371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ight Brace 10"/>
          <p:cNvSpPr/>
          <p:nvPr/>
        </p:nvSpPr>
        <p:spPr>
          <a:xfrm flipV="1" rot="16200000">
            <a:off x="3852720" y="2351520"/>
            <a:ext cx="144360" cy="973440"/>
          </a:xfrm>
          <a:custGeom>
            <a:avLst/>
            <a:gdLst>
              <a:gd name="textAreaLeft" fmla="*/ 0 w 144360"/>
              <a:gd name="textAreaRight" fmla="*/ 52200 w 144360"/>
              <a:gd name="textAreaTop" fmla="*/ 3600 h 973440"/>
              <a:gd name="textAreaBottom" fmla="*/ 969840 h 973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34"/>
                  <a:pt x="10800" y="267"/>
                </a:cubicBezTo>
                <a:lnTo>
                  <a:pt x="10800" y="10533"/>
                </a:lnTo>
                <a:cubicBezTo>
                  <a:pt x="10800" y="10667"/>
                  <a:pt x="16200" y="10800"/>
                  <a:pt x="21600" y="10800"/>
                </a:cubicBezTo>
                <a:cubicBezTo>
                  <a:pt x="16200" y="10800"/>
                  <a:pt x="10800" y="10934"/>
                  <a:pt x="10800" y="11067"/>
                </a:cubicBezTo>
                <a:lnTo>
                  <a:pt x="10800" y="21333"/>
                </a:lnTo>
                <a:cubicBezTo>
                  <a:pt x="10800" y="2146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3741120" y="256068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4:00Z</dcterms:modified>
  <cp:revision>918</cp:revision>
  <dc:subject/>
  <dc:title>PowerPoint Presentation</dc:title>
</cp:coreProperties>
</file>